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1B6A2-18DD-4C63-A81C-2017DD4E82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18FF6-C208-450F-9333-8F2460FD3B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34604-AF03-43BD-AF42-1977A0D889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E2F2C-B791-4BF9-96BD-9B47E29356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1B351-B635-43AB-BF98-CD56EFBE94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6BE46-21B1-4CA1-854B-1425560C37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1A9C1-583B-4EAC-8B7F-46A454886C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C11CB-52F3-46C3-ADE5-E711A05C7D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35698-048D-4B0B-B3CE-E63624BDC2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14FEE4-0BB4-40F1-8397-1DAE8BECD2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9C917-535B-4921-A340-BB0C8FBDE0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D14A3-979C-4E87-BB58-8B8DA0F72F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BDE906-5EBF-4EC9-A8A2-D4132F1392F3}" type="slidenum">
              <a:rPr b="0" lang="el-G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17 - TextBox"/>
          <p:cNvSpPr/>
          <p:nvPr/>
        </p:nvSpPr>
        <p:spPr>
          <a:xfrm>
            <a:off x="363600" y="500040"/>
            <a:ext cx="151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Suppl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21 - Ομάδα"/>
          <p:cNvGrpSpPr/>
          <p:nvPr/>
        </p:nvGrpSpPr>
        <p:grpSpPr>
          <a:xfrm>
            <a:off x="2925720" y="1816200"/>
            <a:ext cx="2870280" cy="3038040"/>
            <a:chOff x="2925720" y="1816200"/>
            <a:chExt cx="2870280" cy="3038040"/>
          </a:xfrm>
        </p:grpSpPr>
        <p:pic>
          <p:nvPicPr>
            <p:cNvPr id="43" name="Picture 3" descr=""/>
            <p:cNvPicPr/>
            <p:nvPr/>
          </p:nvPicPr>
          <p:blipFill>
            <a:blip r:embed="rId1"/>
            <a:stretch/>
          </p:blipFill>
          <p:spPr>
            <a:xfrm>
              <a:off x="4340160" y="2257560"/>
              <a:ext cx="1455840" cy="233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7 - TextBox"/>
            <p:cNvSpPr/>
            <p:nvPr/>
          </p:nvSpPr>
          <p:spPr>
            <a:xfrm>
              <a:off x="4783680" y="4508640"/>
              <a:ext cx="243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8 - TextBox"/>
            <p:cNvSpPr/>
            <p:nvPr/>
          </p:nvSpPr>
          <p:spPr>
            <a:xfrm>
              <a:off x="5270040" y="4508640"/>
              <a:ext cx="281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9 - TextBox"/>
            <p:cNvSpPr/>
            <p:nvPr/>
          </p:nvSpPr>
          <p:spPr>
            <a:xfrm>
              <a:off x="2976120" y="4577760"/>
              <a:ext cx="15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Sars-CoV-2 infection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10 - Ορθογώνιο"/>
            <p:cNvSpPr/>
            <p:nvPr/>
          </p:nvSpPr>
          <p:spPr>
            <a:xfrm>
              <a:off x="2925720" y="2420640"/>
              <a:ext cx="144360" cy="1443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11 - Ορθογώνιο"/>
            <p:cNvSpPr/>
            <p:nvPr/>
          </p:nvSpPr>
          <p:spPr>
            <a:xfrm>
              <a:off x="2925720" y="2658960"/>
              <a:ext cx="144360" cy="144360"/>
            </a:xfrm>
            <a:prstGeom prst="rect">
              <a:avLst/>
            </a:prstGeom>
            <a:solidFill>
              <a:srgbClr val="d9d9d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12 - TextBox"/>
            <p:cNvSpPr/>
            <p:nvPr/>
          </p:nvSpPr>
          <p:spPr>
            <a:xfrm>
              <a:off x="3026520" y="2356920"/>
              <a:ext cx="803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APOBEC3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13 - TextBox"/>
            <p:cNvSpPr/>
            <p:nvPr/>
          </p:nvSpPr>
          <p:spPr>
            <a:xfrm>
              <a:off x="3022200" y="2595600"/>
              <a:ext cx="802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APOBEC3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14 - TextBox"/>
            <p:cNvSpPr/>
            <p:nvPr/>
          </p:nvSpPr>
          <p:spPr>
            <a:xfrm>
              <a:off x="5356440" y="227628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15 - TextBox"/>
            <p:cNvSpPr/>
            <p:nvPr/>
          </p:nvSpPr>
          <p:spPr>
            <a:xfrm rot="16200000">
              <a:off x="3178080" y="3274560"/>
              <a:ext cx="2135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Relative mRNA fold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18 - TextBox"/>
            <p:cNvSpPr/>
            <p:nvPr/>
          </p:nvSpPr>
          <p:spPr>
            <a:xfrm>
              <a:off x="3801600" y="1816200"/>
              <a:ext cx="90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Vero cel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20 - Ευθεία γραμμή σύνδεσης"/>
            <p:cNvSpPr/>
            <p:nvPr/>
          </p:nvSpPr>
          <p:spPr>
            <a:xfrm>
              <a:off x="2925720" y="2131920"/>
              <a:ext cx="273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4-03T11:14:00Z</dcterms:created>
  <dc:creator>Thanos</dc:creator>
  <dc:description/>
  <dc:language>en-US</dc:language>
  <cp:lastModifiedBy>Thanos</cp:lastModifiedBy>
  <dcterms:modified xsi:type="dcterms:W3CDTF">2021-04-03T21:01:15Z</dcterms:modified>
  <cp:revision>8</cp:revision>
  <dc:subject/>
  <dc:title>Διαφάνεια 1</dc:title>
</cp:coreProperties>
</file>